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2" saveSubsetFonts="1">
  <p:sldMasterIdLst>
    <p:sldMasterId id="2147483672" r:id="rId4"/>
  </p:sldMasterIdLst>
  <p:sldIdLst>
    <p:sldId id="271" r:id="rId5"/>
    <p:sldId id="269" r:id="rId6"/>
    <p:sldId id="272" r:id="rId7"/>
    <p:sldId id="268" r:id="rId8"/>
    <p:sldId id="266" r:id="rId9"/>
    <p:sldId id="270" r:id="rId10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F2D6721-8DD9-43AD-7C2B-6EDF57016B70}" name="Colin Selman" initials="CS" userId="S::Colin.Selman@glasgow.ac.uk::814c9d20-62fb-4172-9817-60f50dfb4b12" providerId="AD"/>
  <p188:author id="{225B5ACE-853D-755B-989C-FF75EE7F6E8C}" name="Gillian Borland" initials="GB" userId="S::gillian.borland@glasgow.ac.uk::6fa19246-7eee-4e6e-a5d0-6986a9d96b9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D1B885B-0521-4AC6-AC77-149492D12778}" v="1" dt="2024-02-13T14:41:37.19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4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17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olin Selman" userId="814c9d20-62fb-4172-9817-60f50dfb4b12" providerId="ADAL" clId="{CD1B885B-0521-4AC6-AC77-149492D12778}"/>
    <pc:docChg chg="custSel modSld">
      <pc:chgData name="Colin Selman" userId="814c9d20-62fb-4172-9817-60f50dfb4b12" providerId="ADAL" clId="{CD1B885B-0521-4AC6-AC77-149492D12778}" dt="2024-02-13T14:41:47.186" v="3" actId="14100"/>
      <pc:docMkLst>
        <pc:docMk/>
      </pc:docMkLst>
      <pc:sldChg chg="addSp delSp modSp mod">
        <pc:chgData name="Colin Selman" userId="814c9d20-62fb-4172-9817-60f50dfb4b12" providerId="ADAL" clId="{CD1B885B-0521-4AC6-AC77-149492D12778}" dt="2024-02-13T14:41:47.186" v="3" actId="14100"/>
        <pc:sldMkLst>
          <pc:docMk/>
          <pc:sldMk cId="462813777" sldId="266"/>
        </pc:sldMkLst>
        <pc:picChg chg="add mod">
          <ac:chgData name="Colin Selman" userId="814c9d20-62fb-4172-9817-60f50dfb4b12" providerId="ADAL" clId="{CD1B885B-0521-4AC6-AC77-149492D12778}" dt="2024-02-13T14:41:47.186" v="3" actId="14100"/>
          <ac:picMkLst>
            <pc:docMk/>
            <pc:sldMk cId="462813777" sldId="266"/>
            <ac:picMk id="3" creationId="{8C0C7C73-B087-FFA7-7F63-CC3EED6CCC8C}"/>
          </ac:picMkLst>
        </pc:picChg>
        <pc:picChg chg="del">
          <ac:chgData name="Colin Selman" userId="814c9d20-62fb-4172-9817-60f50dfb4b12" providerId="ADAL" clId="{CD1B885B-0521-4AC6-AC77-149492D12778}" dt="2024-02-13T14:41:34.968" v="0" actId="478"/>
          <ac:picMkLst>
            <pc:docMk/>
            <pc:sldMk cId="462813777" sldId="266"/>
            <ac:picMk id="5" creationId="{33F1C60D-39FD-9D1A-D741-328B14E1207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1008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6973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2915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7406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4444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8634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5503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9915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2057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2400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528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9159D-7C2D-440F-AE21-18599BED2CB8}" type="datetimeFigureOut">
              <a:rPr lang="en-GB" smtClean="0"/>
              <a:t>13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8166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5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4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jpg"/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12" Type="http://schemas.openxmlformats.org/officeDocument/2006/relationships/image" Target="../media/image16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jpg"/><Relationship Id="rId5" Type="http://schemas.openxmlformats.org/officeDocument/2006/relationships/image" Target="../media/image9.jp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jp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C3080-F4F6-3986-C68F-90B1ECB670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47146"/>
            <a:ext cx="9144000" cy="499194"/>
          </a:xfrm>
        </p:spPr>
        <p:txBody>
          <a:bodyPr>
            <a:normAutofit/>
          </a:bodyPr>
          <a:lstStyle/>
          <a:p>
            <a:r>
              <a:rPr lang="en-GB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Legend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9A94EF-461E-E2EB-D2B3-697F2258E6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87296" y="917981"/>
            <a:ext cx="10948501" cy="4863129"/>
          </a:xfrm>
        </p:spPr>
        <p:txBody>
          <a:bodyPr>
            <a:noAutofit/>
          </a:bodyPr>
          <a:lstStyle/>
          <a:p>
            <a:pPr algn="l"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 Schematic representation of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RISPR/Cas9-mediated 8bp insertion in the 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olr3b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gene resulting in a frameshift mutation and early truncation in one allele of 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olr3b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 Sequences of Polr3b WT (top) and knockout (bottom) alleles are shown from nucleotide 10070 of the WT gene sequence (</a:t>
            </a:r>
            <a:r>
              <a:rPr lang="en-GB" sz="1200" b="0" i="0" u="none" strike="noStrike" dirty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C_000076.7). The 8bp insertion is highlighted in yellow; sequences for primers used in genotyping are shown in blue (WT allele) or red (KO allele).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(B) Example of PCR genotyping of skin from wild type and Polr3b</a:t>
            </a:r>
            <a:r>
              <a:rPr lang="en-GB" sz="1200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+/-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mice. </a:t>
            </a:r>
          </a:p>
          <a:p>
            <a:pPr algn="l">
              <a:lnSpc>
                <a:spcPct val="150000"/>
              </a:lnSpc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. S2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 Representative immunoblots in liver are shown for POLR3b (and total protein) with the molecular mass (in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kDa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for POLR3b shown in A) 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female (t=2.721, p= 0.019) </a:t>
            </a:r>
            <a:r>
              <a:rPr lang="en-GB" sz="120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and B) 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male (t=1.034, p=0.323) </a:t>
            </a:r>
            <a:r>
              <a:rPr lang="en-GB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WT and </a:t>
            </a:r>
            <a:r>
              <a:rPr kumimoji="0" lang="en-GB" sz="1200" b="0" i="1" u="none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olr3b</a:t>
            </a:r>
            <a:r>
              <a:rPr kumimoji="0" lang="en-GB" sz="1200" b="0" i="1" u="none" strike="noStrike" kern="1200" cap="none" spc="0" normalizeH="0" baseline="3000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/-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mice at 5 months of age. 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Histograms denote </a:t>
            </a:r>
            <a:r>
              <a:rPr lang="en-GB" sz="1200" dirty="0" err="1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ean±SEM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 with sample sizes indicated by individual points within a group. </a:t>
            </a:r>
          </a:p>
          <a:p>
            <a:pPr algn="l">
              <a:lnSpc>
                <a:spcPct val="150000"/>
              </a:lnSpc>
            </a:pP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 S3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GB" sz="1200" b="0" i="0" u="none" strike="noStrike" dirty="0" err="1">
                <a:solidFill>
                  <a:srgbClr val="282828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icroCT</a:t>
            </a:r>
            <a:r>
              <a:rPr lang="en-GB" sz="1200" b="0" i="0" u="none" strike="noStrike" dirty="0">
                <a:solidFill>
                  <a:srgbClr val="282828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alysis of femurs from WT and </a:t>
            </a:r>
            <a:r>
              <a:rPr lang="en-GB" sz="1200" b="0" i="1" u="none" strike="noStrike" dirty="0">
                <a:solidFill>
                  <a:srgbClr val="282828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lr3b</a:t>
            </a:r>
            <a:r>
              <a:rPr lang="en-GB" sz="1200" b="0" i="1" u="none" strike="noStrike" baseline="30000" dirty="0">
                <a:solidFill>
                  <a:srgbClr val="282828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GB" sz="1200" b="0" i="0" u="none" strike="noStrike" dirty="0">
                <a:solidFill>
                  <a:srgbClr val="282828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female mice was performed and representative 2D images of transverse sections through femurs (upper left and lower right boxes) are shown while cross-sectional analysis provides a 2D image of the cortical bone (lower left box). Upper right box shows trabecular structure. 3 representative images per genotype are shown. </a:t>
            </a:r>
          </a:p>
          <a:p>
            <a:pPr algn="just">
              <a:lnSpc>
                <a:spcPct val="150000"/>
              </a:lnSpc>
            </a:pPr>
            <a:r>
              <a:rPr lang="en-GB" sz="1200" b="1" kern="0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r>
              <a:rPr lang="en-GB" sz="1200" kern="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A) Percentage bone volume, (B) Trabecular separation and (C) Trabecular number in femurs from male WT and </a:t>
            </a:r>
            <a:r>
              <a:rPr kumimoji="0" lang="en-GB" sz="1200" b="0" i="1" u="none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olr3b</a:t>
            </a:r>
            <a:r>
              <a:rPr kumimoji="0" lang="en-GB" sz="1200" b="0" i="1" u="none" strike="noStrike" kern="1200" cap="none" spc="0" normalizeH="0" baseline="3000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/-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ice at 20 months of age. 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(D) food intake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in female and male WT and </a:t>
            </a:r>
            <a:r>
              <a:rPr kumimoji="0" lang="en-GB" sz="1200" b="0" i="1" u="none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olr3b</a:t>
            </a:r>
            <a:r>
              <a:rPr kumimoji="0" lang="en-GB" sz="1200" b="0" i="1" u="none" strike="noStrike" kern="1200" cap="none" spc="0" normalizeH="0" baseline="3000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/-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 mice at 20 months of age. Measurements in female and male </a:t>
            </a:r>
            <a:r>
              <a:rPr lang="en-GB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WT and </a:t>
            </a:r>
            <a:r>
              <a:rPr kumimoji="0" lang="en-GB" sz="1200" b="0" i="1" u="none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olr3b</a:t>
            </a:r>
            <a:r>
              <a:rPr kumimoji="0" lang="en-GB" sz="1200" b="0" i="1" u="none" strike="noStrike" kern="1200" cap="none" spc="0" normalizeH="0" baseline="3000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/-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mice at 4 and 20 months of age for (E) Fasting blood glucose, (F) AUC following glucose tolerance test, (G) Fasting plasma insulin, (H) Fasting plasma IGF-1 and (I) Fed blood glucose. (J) Grip strength at 18, 24 and 27 months of age (n= 8-12 per group). 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Histograms denote </a:t>
            </a:r>
            <a:r>
              <a:rPr lang="en-GB" sz="1200" dirty="0" err="1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ean±SEM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 with sample sizes indicated by individual points within a group. Where significant, genotype, age and sex effects indicated. </a:t>
            </a:r>
          </a:p>
          <a:p>
            <a:pPr algn="just"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5. </a:t>
            </a:r>
            <a:r>
              <a:rPr lang="en-GB" sz="1200" kern="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ximum lifespan (oldest 10% of cohort, </a:t>
            </a:r>
            <a:r>
              <a:rPr lang="en-GB" sz="1200" dirty="0" err="1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ean±SEM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for </a:t>
            </a:r>
            <a:r>
              <a:rPr lang="en-GB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ombined sexes (A, where n=10 per group), female 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B, where n=5 per group), male (C, where n= 5 per group) </a:t>
            </a:r>
            <a:r>
              <a:rPr lang="en-GB" sz="1200" kern="0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ld-type and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GB" sz="1200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lr3b</a:t>
            </a:r>
            <a:r>
              <a:rPr kumimoji="0" lang="en-GB" sz="1200" b="0" i="1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/-</a:t>
            </a:r>
            <a:r>
              <a:rPr kumimoji="0" lang="en-GB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. (D) 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Kaplan-Meier survival curve for female mice where mice that were culled for idiopathic dermatitis (ID) were censored (Log-rank X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=0.021, p= 0.885; n= 46 for WT and n= 30 for </a:t>
            </a:r>
            <a:r>
              <a:rPr lang="en-GB" sz="1200" i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olr3b</a:t>
            </a:r>
            <a:r>
              <a:rPr lang="en-GB" sz="1200" i="1" baseline="300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+/- </a:t>
            </a:r>
            <a:r>
              <a:rPr lang="en-GB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ice), where numbers denote median lifespan (days). 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71161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9331087-F16C-1F14-90FC-B3166D5C00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18428" cy="681661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09D8B42-9F6D-359B-DE74-5C2C98958880}"/>
              </a:ext>
            </a:extLst>
          </p:cNvPr>
          <p:cNvSpPr txBox="1"/>
          <p:nvPr/>
        </p:nvSpPr>
        <p:spPr>
          <a:xfrm>
            <a:off x="209725" y="285226"/>
            <a:ext cx="105253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b="1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4563848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9F1DB34-5495-9B1B-085B-9C3944128E28}"/>
              </a:ext>
            </a:extLst>
          </p:cNvPr>
          <p:cNvSpPr txBox="1"/>
          <p:nvPr/>
        </p:nvSpPr>
        <p:spPr>
          <a:xfrm>
            <a:off x="209725" y="285226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S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0E259C5-49E0-CC78-E465-F92D0FAF88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2478" y="3553922"/>
            <a:ext cx="4975965" cy="288105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6466C9E-3EBB-861F-94B3-CBD5600A8D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1" y="3553922"/>
            <a:ext cx="4975966" cy="288105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2857858-5A62-34F1-C4A0-37A459853A12}"/>
              </a:ext>
            </a:extLst>
          </p:cNvPr>
          <p:cNvSpPr txBox="1"/>
          <p:nvPr/>
        </p:nvSpPr>
        <p:spPr>
          <a:xfrm>
            <a:off x="1937857" y="55367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D8AC557-6625-7FED-50CB-0EF587DECCCC}"/>
              </a:ext>
            </a:extLst>
          </p:cNvPr>
          <p:cNvSpPr txBox="1"/>
          <p:nvPr/>
        </p:nvSpPr>
        <p:spPr>
          <a:xfrm>
            <a:off x="7568274" y="54668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/>
              <a:t>B</a:t>
            </a:r>
            <a:endParaRPr lang="en-GB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EF68C9-38B0-81F6-1F76-646022D7D862}"/>
              </a:ext>
            </a:extLst>
          </p:cNvPr>
          <p:cNvSpPr txBox="1"/>
          <p:nvPr/>
        </p:nvSpPr>
        <p:spPr>
          <a:xfrm>
            <a:off x="226503" y="3822586"/>
            <a:ext cx="1174458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OLR3b (128kDA)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9F385D9-9265-3871-19D1-DC7CCEB9BD49}"/>
              </a:ext>
            </a:extLst>
          </p:cNvPr>
          <p:cNvSpPr txBox="1"/>
          <p:nvPr/>
        </p:nvSpPr>
        <p:spPr>
          <a:xfrm>
            <a:off x="5873698" y="3865929"/>
            <a:ext cx="1174458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OLR3b (128kDA)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3BC6189-930D-E227-BC38-2B077591EDF6}"/>
              </a:ext>
            </a:extLst>
          </p:cNvPr>
          <p:cNvSpPr txBox="1"/>
          <p:nvPr/>
        </p:nvSpPr>
        <p:spPr>
          <a:xfrm>
            <a:off x="10628851" y="3665989"/>
            <a:ext cx="443116" cy="43077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880F2E3-48EB-6E7F-79F2-3739E7F88148}"/>
              </a:ext>
            </a:extLst>
          </p:cNvPr>
          <p:cNvSpPr txBox="1"/>
          <p:nvPr/>
        </p:nvSpPr>
        <p:spPr>
          <a:xfrm>
            <a:off x="5035327" y="3672982"/>
            <a:ext cx="443116" cy="43077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2DA8D36A-9DB9-9407-A4D4-801746E31E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7483691"/>
              </p:ext>
            </p:extLst>
          </p:nvPr>
        </p:nvGraphicFramePr>
        <p:xfrm>
          <a:off x="2322742" y="179387"/>
          <a:ext cx="2592387" cy="3249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591897" imgH="3250390" progId="Prism9.Document">
                  <p:embed/>
                </p:oleObj>
              </mc:Choice>
              <mc:Fallback>
                <p:oleObj name="Prism 9" r:id="rId4" imgW="2591897" imgH="3250390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2DA8D36A-9DB9-9407-A4D4-801746E31E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22742" y="179387"/>
                        <a:ext cx="2592387" cy="3249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A15345FC-8122-1C15-A797-FE3FDAAE01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4074846"/>
              </p:ext>
            </p:extLst>
          </p:nvPr>
        </p:nvGraphicFramePr>
        <p:xfrm>
          <a:off x="7903157" y="407987"/>
          <a:ext cx="2455863" cy="3021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456126" imgH="3021692" progId="Prism9.Document">
                  <p:embed/>
                </p:oleObj>
              </mc:Choice>
              <mc:Fallback>
                <p:oleObj name="Prism 9" r:id="rId6" imgW="2456126" imgH="3021692" progId="Prism9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A15345FC-8122-1C15-A797-FE3FDAAE01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903157" y="407987"/>
                        <a:ext cx="2455863" cy="3021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077846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03F2651-11C2-5EF7-3122-9F8687F1F692}"/>
              </a:ext>
            </a:extLst>
          </p:cNvPr>
          <p:cNvSpPr txBox="1"/>
          <p:nvPr/>
        </p:nvSpPr>
        <p:spPr>
          <a:xfrm>
            <a:off x="209725" y="285226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S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AEADAE7-73BD-4425-6E7D-4ADE533E57B4}"/>
              </a:ext>
            </a:extLst>
          </p:cNvPr>
          <p:cNvSpPr txBox="1"/>
          <p:nvPr/>
        </p:nvSpPr>
        <p:spPr>
          <a:xfrm rot="16200000">
            <a:off x="1514335" y="2135505"/>
            <a:ext cx="17987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ild-type</a:t>
            </a:r>
            <a:r>
              <a:rPr lang="en-US" i="1" dirty="0"/>
              <a:t> </a:t>
            </a:r>
            <a:r>
              <a:rPr lang="en-US" dirty="0"/>
              <a:t>femur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E54E34B-F6B8-9716-1570-9A0A15F3C208}"/>
              </a:ext>
            </a:extLst>
          </p:cNvPr>
          <p:cNvSpPr txBox="1"/>
          <p:nvPr/>
        </p:nvSpPr>
        <p:spPr>
          <a:xfrm rot="16200000">
            <a:off x="1573550" y="4408540"/>
            <a:ext cx="1680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Polr3b</a:t>
            </a:r>
            <a:r>
              <a:rPr lang="en-US" i="1" baseline="30000" dirty="0"/>
              <a:t>+/-</a:t>
            </a:r>
            <a:r>
              <a:rPr lang="en-US" dirty="0"/>
              <a:t> femurs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D6A8CBF4-E84A-2578-9174-40357CA87844}"/>
              </a:ext>
            </a:extLst>
          </p:cNvPr>
          <p:cNvGrpSpPr/>
          <p:nvPr/>
        </p:nvGrpSpPr>
        <p:grpSpPr>
          <a:xfrm>
            <a:off x="2669357" y="1240171"/>
            <a:ext cx="2160000" cy="2160000"/>
            <a:chOff x="2313757" y="655971"/>
            <a:chExt cx="2160000" cy="216000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53A7657-3B91-FDDE-B369-B0D310BF82A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13757" y="655971"/>
              <a:ext cx="2160000" cy="21600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3610922-A4F7-4F23-4C61-F93C30072D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4204" t="22822" r="32723" b="17165"/>
            <a:stretch/>
          </p:blipFill>
          <p:spPr>
            <a:xfrm>
              <a:off x="3424665" y="666414"/>
              <a:ext cx="1032273" cy="1033200"/>
            </a:xfrm>
            <a:prstGeom prst="rect">
              <a:avLst/>
            </a:prstGeom>
          </p:spPr>
        </p:pic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FE128037-A699-53D2-D8A0-FC2FAA0CD861}"/>
              </a:ext>
            </a:extLst>
          </p:cNvPr>
          <p:cNvGrpSpPr/>
          <p:nvPr/>
        </p:nvGrpSpPr>
        <p:grpSpPr>
          <a:xfrm>
            <a:off x="4938752" y="1240171"/>
            <a:ext cx="2160000" cy="2160000"/>
            <a:chOff x="4519652" y="655971"/>
            <a:chExt cx="2160000" cy="216000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D21D25F7-0874-EA51-F908-C4A12153A47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19652" y="655971"/>
              <a:ext cx="2160000" cy="21600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12CD08B-4F7A-2FC4-7A5C-F3751CBBB5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3376" t="26009" r="33551" b="13977"/>
            <a:stretch/>
          </p:blipFill>
          <p:spPr>
            <a:xfrm>
              <a:off x="5626928" y="666057"/>
              <a:ext cx="1032274" cy="1033200"/>
            </a:xfrm>
            <a:prstGeom prst="rect">
              <a:avLst/>
            </a:prstGeom>
          </p:spPr>
        </p:pic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D456158-4549-5110-BB4A-525600B458CB}"/>
              </a:ext>
            </a:extLst>
          </p:cNvPr>
          <p:cNvGrpSpPr/>
          <p:nvPr/>
        </p:nvGrpSpPr>
        <p:grpSpPr>
          <a:xfrm>
            <a:off x="7208147" y="1240171"/>
            <a:ext cx="2160000" cy="2160000"/>
            <a:chOff x="6725547" y="655971"/>
            <a:chExt cx="2160000" cy="2160000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28F51936-F352-11FD-F9FF-703C2CA6518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725547" y="655971"/>
              <a:ext cx="2160000" cy="21600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DAF466C0-EE08-3D85-E152-30C9013C26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3838" t="21177" r="33088" b="18808"/>
            <a:stretch/>
          </p:blipFill>
          <p:spPr>
            <a:xfrm>
              <a:off x="7835805" y="668436"/>
              <a:ext cx="1032273" cy="1033200"/>
            </a:xfrm>
            <a:prstGeom prst="rect">
              <a:avLst/>
            </a:prstGeom>
          </p:spPr>
        </p:pic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9E43095-7D0F-9205-857A-3D23C0CD1B8F}"/>
              </a:ext>
            </a:extLst>
          </p:cNvPr>
          <p:cNvGrpSpPr/>
          <p:nvPr/>
        </p:nvGrpSpPr>
        <p:grpSpPr>
          <a:xfrm>
            <a:off x="2669357" y="3513206"/>
            <a:ext cx="2160000" cy="2160000"/>
            <a:chOff x="2313757" y="2865506"/>
            <a:chExt cx="2160000" cy="2160000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2916D8D-923C-B222-E120-5DD838F58C0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313757" y="2865506"/>
              <a:ext cx="2160000" cy="21600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56192FE6-BF19-B4F6-AC84-A47F54881D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34203" t="21372" r="32723" b="18615"/>
            <a:stretch/>
          </p:blipFill>
          <p:spPr>
            <a:xfrm>
              <a:off x="3428432" y="2878812"/>
              <a:ext cx="1032274" cy="1033200"/>
            </a:xfrm>
            <a:prstGeom prst="rect">
              <a:avLst/>
            </a:prstGeom>
          </p:spPr>
        </p:pic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64087A3D-A4EC-64F9-1EE0-5C644C65E6CC}"/>
              </a:ext>
            </a:extLst>
          </p:cNvPr>
          <p:cNvGrpSpPr/>
          <p:nvPr/>
        </p:nvGrpSpPr>
        <p:grpSpPr>
          <a:xfrm>
            <a:off x="4938752" y="3513206"/>
            <a:ext cx="2160000" cy="2160000"/>
            <a:chOff x="4519652" y="2865506"/>
            <a:chExt cx="2160000" cy="2160000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1DD0DB93-035D-5A6A-724E-7D8272833C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519652" y="2865506"/>
              <a:ext cx="2160000" cy="21600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B973A684-6296-27C9-9709-6321A60F0A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32679" t="21372" r="36081" b="22065"/>
            <a:stretch/>
          </p:blipFill>
          <p:spPr>
            <a:xfrm>
              <a:off x="5684141" y="2885536"/>
              <a:ext cx="975061" cy="973770"/>
            </a:xfrm>
            <a:prstGeom prst="rect">
              <a:avLst/>
            </a:prstGeom>
          </p:spPr>
        </p:pic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3CAF8AFF-19B7-0E85-D032-B498A0916691}"/>
              </a:ext>
            </a:extLst>
          </p:cNvPr>
          <p:cNvGrpSpPr/>
          <p:nvPr/>
        </p:nvGrpSpPr>
        <p:grpSpPr>
          <a:xfrm>
            <a:off x="7208147" y="3513206"/>
            <a:ext cx="2160000" cy="2160000"/>
            <a:chOff x="6725547" y="2865506"/>
            <a:chExt cx="2160000" cy="2160000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D1AB6E90-0BB0-8729-52B8-6D71BAD20F84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6725547" y="2865506"/>
              <a:ext cx="2160000" cy="216000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6897236F-0E41-0E3C-8553-DE64F6B408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33838" t="23393" r="34058" b="17990"/>
            <a:stretch/>
          </p:blipFill>
          <p:spPr>
            <a:xfrm>
              <a:off x="7866063" y="2875450"/>
              <a:ext cx="1002015" cy="100915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695142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03F2651-11C2-5EF7-3122-9F8687F1F692}"/>
              </a:ext>
            </a:extLst>
          </p:cNvPr>
          <p:cNvSpPr txBox="1"/>
          <p:nvPr/>
        </p:nvSpPr>
        <p:spPr>
          <a:xfrm>
            <a:off x="209725" y="285226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S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C0C7C73-B087-FFA7-7F63-CC3EED6CCC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1837" y="195942"/>
            <a:ext cx="8488326" cy="6494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28137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03F2651-11C2-5EF7-3122-9F8687F1F692}"/>
              </a:ext>
            </a:extLst>
          </p:cNvPr>
          <p:cNvSpPr txBox="1"/>
          <p:nvPr/>
        </p:nvSpPr>
        <p:spPr>
          <a:xfrm>
            <a:off x="209725" y="285226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S5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C0E398F-2D3E-256F-E41E-1854B7D742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411421"/>
              </p:ext>
            </p:extLst>
          </p:nvPr>
        </p:nvGraphicFramePr>
        <p:xfrm>
          <a:off x="2474913" y="138113"/>
          <a:ext cx="7242175" cy="6580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7241609" imgH="6580374" progId="Prism9.Document">
                  <p:embed/>
                </p:oleObj>
              </mc:Choice>
              <mc:Fallback>
                <p:oleObj name="Prism 9" r:id="rId2" imgW="7241609" imgH="6580374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7C0E398F-2D3E-256F-E41E-1854B7D742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74913" y="138113"/>
                        <a:ext cx="7242175" cy="6580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95358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C5E1FE38DA6544EBCD92531E80C1992" ma:contentTypeVersion="17" ma:contentTypeDescription="Create a new document." ma:contentTypeScope="" ma:versionID="97f289b17692828bf11e1a2dd9f85cd8">
  <xsd:schema xmlns:xsd="http://www.w3.org/2001/XMLSchema" xmlns:xs="http://www.w3.org/2001/XMLSchema" xmlns:p="http://schemas.microsoft.com/office/2006/metadata/properties" xmlns:ns2="80a5973c-c1b7-4316-8b87-a29795785b25" xmlns:ns3="422793d5-3ed3-4929-8744-ffb85abedb4b" targetNamespace="http://schemas.microsoft.com/office/2006/metadata/properties" ma:root="true" ma:fieldsID="579f99a7b84045f15e717956ae2a6907" ns2:_="" ns3:_="">
    <xsd:import namespace="80a5973c-c1b7-4316-8b87-a29795785b25"/>
    <xsd:import namespace="422793d5-3ed3-4929-8744-ffb85abedb4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2:MediaServiceObjectDetectorVersions" minOccurs="0"/>
                <xsd:element ref="ns2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0a5973c-c1b7-4316-8b87-a29795785b2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20" nillable="true" ma:taxonomy="true" ma:internalName="lcf76f155ced4ddcb4097134ff3c332f" ma:taxonomyFieldName="MediaServiceImageTags" ma:displayName="Image Tags" ma:readOnly="false" ma:fieldId="{5cf76f15-5ced-4ddc-b409-7134ff3c332f}" ma:taxonomyMulti="true" ma:sspId="7306b285-ac2c-4225-b56d-e54690cf9c9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2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22793d5-3ed3-4929-8744-ffb85abedb4b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dbe73721-18ff-471f-b983-a094a73a5ccd}" ma:internalName="TaxCatchAll" ma:showField="CatchAllData" ma:web="422793d5-3ed3-4929-8744-ffb85abedb4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22793d5-3ed3-4929-8744-ffb85abedb4b" xsi:nil="true"/>
    <lcf76f155ced4ddcb4097134ff3c332f xmlns="80a5973c-c1b7-4316-8b87-a29795785b25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645EB7D4-0061-4279-BBFB-93B4B003386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FF69939-346F-4861-8889-110434863CA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0a5973c-c1b7-4316-8b87-a29795785b25"/>
    <ds:schemaRef ds:uri="422793d5-3ed3-4929-8744-ffb85abedb4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31A8993-4C8E-47D9-837D-632AF0730071}">
  <ds:schemaRefs>
    <ds:schemaRef ds:uri="http://schemas.microsoft.com/office/2006/metadata/properties"/>
    <ds:schemaRef ds:uri="http://schemas.microsoft.com/office/infopath/2007/PartnerControls"/>
    <ds:schemaRef ds:uri="422793d5-3ed3-4929-8744-ffb85abedb4b"/>
    <ds:schemaRef ds:uri="80a5973c-c1b7-4316-8b87-a29795785b25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015</TotalTime>
  <Words>552</Words>
  <Application>Microsoft Office PowerPoint</Application>
  <PresentationFormat>Widescreen</PresentationFormat>
  <Paragraphs>17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9</vt:lpstr>
      <vt:lpstr>Supplementary Figure Legend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Selman</dc:creator>
  <cp:lastModifiedBy>Colin Selman</cp:lastModifiedBy>
  <cp:revision>26</cp:revision>
  <cp:lastPrinted>2023-10-09T13:44:26Z</cp:lastPrinted>
  <dcterms:created xsi:type="dcterms:W3CDTF">2023-08-23T10:50:58Z</dcterms:created>
  <dcterms:modified xsi:type="dcterms:W3CDTF">2024-02-13T14:41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C5E1FE38DA6544EBCD92531E80C1992</vt:lpwstr>
  </property>
</Properties>
</file>